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3" r:id="rId2"/>
    <p:sldId id="274" r:id="rId3"/>
    <p:sldId id="267" r:id="rId4"/>
    <p:sldId id="266" r:id="rId5"/>
    <p:sldId id="264" r:id="rId6"/>
    <p:sldId id="268" r:id="rId7"/>
    <p:sldId id="272" r:id="rId8"/>
  </p:sldIdLst>
  <p:sldSz cx="15119350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211" autoAdjust="0"/>
    <p:restoredTop sz="94660"/>
  </p:normalViewPr>
  <p:slideViewPr>
    <p:cSldViewPr snapToGrid="0">
      <p:cViewPr varScale="1">
        <p:scale>
          <a:sx n="71" d="100"/>
          <a:sy n="71" d="100"/>
        </p:scale>
        <p:origin x="63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33951" y="1749798"/>
            <a:ext cx="12851448" cy="3722335"/>
          </a:xfrm>
        </p:spPr>
        <p:txBody>
          <a:bodyPr anchor="b"/>
          <a:lstStyle>
            <a:lvl1pPr algn="ctr">
              <a:defRPr sz="9353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89925" y="5615681"/>
            <a:ext cx="11339513" cy="2581379"/>
          </a:xfrm>
        </p:spPr>
        <p:txBody>
          <a:bodyPr/>
          <a:lstStyle>
            <a:lvl1pPr marL="0" indent="0" algn="ctr">
              <a:buNone/>
              <a:defRPr sz="3742"/>
            </a:lvl1pPr>
            <a:lvl2pPr marL="712751" indent="0" algn="ctr">
              <a:buNone/>
              <a:defRPr sz="3118"/>
            </a:lvl2pPr>
            <a:lvl3pPr marL="1425501" indent="0" algn="ctr">
              <a:buNone/>
              <a:defRPr sz="2806"/>
            </a:lvl3pPr>
            <a:lvl4pPr marL="2138250" indent="0" algn="ctr">
              <a:buNone/>
              <a:defRPr sz="2494"/>
            </a:lvl4pPr>
            <a:lvl5pPr marL="2851001" indent="0" algn="ctr">
              <a:buNone/>
              <a:defRPr sz="2494"/>
            </a:lvl5pPr>
            <a:lvl6pPr marL="3563752" indent="0" algn="ctr">
              <a:buNone/>
              <a:defRPr sz="2494"/>
            </a:lvl6pPr>
            <a:lvl7pPr marL="4276502" indent="0" algn="ctr">
              <a:buNone/>
              <a:defRPr sz="2494"/>
            </a:lvl7pPr>
            <a:lvl8pPr marL="4989253" indent="0" algn="ctr">
              <a:buNone/>
              <a:defRPr sz="2494"/>
            </a:lvl8pPr>
            <a:lvl9pPr marL="5702002" indent="0" algn="ctr">
              <a:buNone/>
              <a:defRPr sz="2494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91085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59382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819786" y="569240"/>
            <a:ext cx="3260110" cy="9060817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39456" y="569240"/>
            <a:ext cx="9591338" cy="9060817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04009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75931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1588" y="2665532"/>
            <a:ext cx="13040439" cy="4447496"/>
          </a:xfrm>
        </p:spPr>
        <p:txBody>
          <a:bodyPr anchor="b"/>
          <a:lstStyle>
            <a:lvl1pPr>
              <a:defRPr sz="9353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1588" y="7155106"/>
            <a:ext cx="13040439" cy="2338833"/>
          </a:xfrm>
        </p:spPr>
        <p:txBody>
          <a:bodyPr/>
          <a:lstStyle>
            <a:lvl1pPr marL="0" indent="0">
              <a:buNone/>
              <a:defRPr sz="3742">
                <a:solidFill>
                  <a:schemeClr val="tx1"/>
                </a:solidFill>
              </a:defRPr>
            </a:lvl1pPr>
            <a:lvl2pPr marL="712751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2pPr>
            <a:lvl3pPr marL="1425501" indent="0">
              <a:buNone/>
              <a:defRPr sz="2806">
                <a:solidFill>
                  <a:schemeClr val="tx1">
                    <a:tint val="75000"/>
                  </a:schemeClr>
                </a:solidFill>
              </a:defRPr>
            </a:lvl3pPr>
            <a:lvl4pPr marL="2138250" indent="0">
              <a:buNone/>
              <a:defRPr sz="2494">
                <a:solidFill>
                  <a:schemeClr val="tx1">
                    <a:tint val="75000"/>
                  </a:schemeClr>
                </a:solidFill>
              </a:defRPr>
            </a:lvl4pPr>
            <a:lvl5pPr marL="2851001" indent="0">
              <a:buNone/>
              <a:defRPr sz="2494">
                <a:solidFill>
                  <a:schemeClr val="tx1">
                    <a:tint val="75000"/>
                  </a:schemeClr>
                </a:solidFill>
              </a:defRPr>
            </a:lvl5pPr>
            <a:lvl6pPr marL="3563752" indent="0">
              <a:buNone/>
              <a:defRPr sz="2494">
                <a:solidFill>
                  <a:schemeClr val="tx1">
                    <a:tint val="75000"/>
                  </a:schemeClr>
                </a:solidFill>
              </a:defRPr>
            </a:lvl6pPr>
            <a:lvl7pPr marL="4276502" indent="0">
              <a:buNone/>
              <a:defRPr sz="2494">
                <a:solidFill>
                  <a:schemeClr val="tx1">
                    <a:tint val="75000"/>
                  </a:schemeClr>
                </a:solidFill>
              </a:defRPr>
            </a:lvl7pPr>
            <a:lvl8pPr marL="4989253" indent="0">
              <a:buNone/>
              <a:defRPr sz="2494">
                <a:solidFill>
                  <a:schemeClr val="tx1">
                    <a:tint val="75000"/>
                  </a:schemeClr>
                </a:solidFill>
              </a:defRPr>
            </a:lvl8pPr>
            <a:lvl9pPr marL="5702002" indent="0">
              <a:buNone/>
              <a:defRPr sz="249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1518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39455" y="2846203"/>
            <a:ext cx="6425724" cy="6783857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54171" y="2846203"/>
            <a:ext cx="6425724" cy="6783857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82356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31" y="569242"/>
            <a:ext cx="13040439" cy="2066590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1432" y="2620980"/>
            <a:ext cx="6396193" cy="1284502"/>
          </a:xfrm>
        </p:spPr>
        <p:txBody>
          <a:bodyPr anchor="b"/>
          <a:lstStyle>
            <a:lvl1pPr marL="0" indent="0">
              <a:buNone/>
              <a:defRPr sz="3742" b="1"/>
            </a:lvl1pPr>
            <a:lvl2pPr marL="712751" indent="0">
              <a:buNone/>
              <a:defRPr sz="3118" b="1"/>
            </a:lvl2pPr>
            <a:lvl3pPr marL="1425501" indent="0">
              <a:buNone/>
              <a:defRPr sz="2806" b="1"/>
            </a:lvl3pPr>
            <a:lvl4pPr marL="2138250" indent="0">
              <a:buNone/>
              <a:defRPr sz="2494" b="1"/>
            </a:lvl4pPr>
            <a:lvl5pPr marL="2851001" indent="0">
              <a:buNone/>
              <a:defRPr sz="2494" b="1"/>
            </a:lvl5pPr>
            <a:lvl6pPr marL="3563752" indent="0">
              <a:buNone/>
              <a:defRPr sz="2494" b="1"/>
            </a:lvl6pPr>
            <a:lvl7pPr marL="4276502" indent="0">
              <a:buNone/>
              <a:defRPr sz="2494" b="1"/>
            </a:lvl7pPr>
            <a:lvl8pPr marL="4989253" indent="0">
              <a:buNone/>
              <a:defRPr sz="2494" b="1"/>
            </a:lvl8pPr>
            <a:lvl9pPr marL="5702002" indent="0">
              <a:buNone/>
              <a:defRPr sz="2494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1432" y="3905484"/>
            <a:ext cx="6396193" cy="5744375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654178" y="2620980"/>
            <a:ext cx="6427693" cy="1284502"/>
          </a:xfrm>
        </p:spPr>
        <p:txBody>
          <a:bodyPr anchor="b"/>
          <a:lstStyle>
            <a:lvl1pPr marL="0" indent="0">
              <a:buNone/>
              <a:defRPr sz="3742" b="1"/>
            </a:lvl1pPr>
            <a:lvl2pPr marL="712751" indent="0">
              <a:buNone/>
              <a:defRPr sz="3118" b="1"/>
            </a:lvl2pPr>
            <a:lvl3pPr marL="1425501" indent="0">
              <a:buNone/>
              <a:defRPr sz="2806" b="1"/>
            </a:lvl3pPr>
            <a:lvl4pPr marL="2138250" indent="0">
              <a:buNone/>
              <a:defRPr sz="2494" b="1"/>
            </a:lvl4pPr>
            <a:lvl5pPr marL="2851001" indent="0">
              <a:buNone/>
              <a:defRPr sz="2494" b="1"/>
            </a:lvl5pPr>
            <a:lvl6pPr marL="3563752" indent="0">
              <a:buNone/>
              <a:defRPr sz="2494" b="1"/>
            </a:lvl6pPr>
            <a:lvl7pPr marL="4276502" indent="0">
              <a:buNone/>
              <a:defRPr sz="2494" b="1"/>
            </a:lvl7pPr>
            <a:lvl8pPr marL="4989253" indent="0">
              <a:buNone/>
              <a:defRPr sz="2494" b="1"/>
            </a:lvl8pPr>
            <a:lvl9pPr marL="5702002" indent="0">
              <a:buNone/>
              <a:defRPr sz="2494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654178" y="3905484"/>
            <a:ext cx="6427693" cy="5744375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2480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7396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03200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712788"/>
            <a:ext cx="4876384" cy="2494756"/>
          </a:xfrm>
        </p:spPr>
        <p:txBody>
          <a:bodyPr anchor="b"/>
          <a:lstStyle>
            <a:lvl1pPr>
              <a:defRPr sz="4989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27699" y="1539428"/>
            <a:ext cx="7654171" cy="7598117"/>
          </a:xfrm>
        </p:spPr>
        <p:txBody>
          <a:bodyPr/>
          <a:lstStyle>
            <a:lvl1pPr>
              <a:defRPr sz="4989"/>
            </a:lvl1pPr>
            <a:lvl2pPr>
              <a:defRPr sz="4365"/>
            </a:lvl2pPr>
            <a:lvl3pPr>
              <a:defRPr sz="3742"/>
            </a:lvl3pPr>
            <a:lvl4pPr>
              <a:defRPr sz="3118"/>
            </a:lvl4pPr>
            <a:lvl5pPr>
              <a:defRPr sz="3118"/>
            </a:lvl5pPr>
            <a:lvl6pPr>
              <a:defRPr sz="3118"/>
            </a:lvl6pPr>
            <a:lvl7pPr>
              <a:defRPr sz="3118"/>
            </a:lvl7pPr>
            <a:lvl8pPr>
              <a:defRPr sz="3118"/>
            </a:lvl8pPr>
            <a:lvl9pPr>
              <a:defRPr sz="3118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3207544"/>
            <a:ext cx="4876384" cy="5942372"/>
          </a:xfrm>
        </p:spPr>
        <p:txBody>
          <a:bodyPr/>
          <a:lstStyle>
            <a:lvl1pPr marL="0" indent="0">
              <a:buNone/>
              <a:defRPr sz="2494"/>
            </a:lvl1pPr>
            <a:lvl2pPr marL="712751" indent="0">
              <a:buNone/>
              <a:defRPr sz="2183"/>
            </a:lvl2pPr>
            <a:lvl3pPr marL="1425501" indent="0">
              <a:buNone/>
              <a:defRPr sz="1871"/>
            </a:lvl3pPr>
            <a:lvl4pPr marL="2138250" indent="0">
              <a:buNone/>
              <a:defRPr sz="1559"/>
            </a:lvl4pPr>
            <a:lvl5pPr marL="2851001" indent="0">
              <a:buNone/>
              <a:defRPr sz="1559"/>
            </a:lvl5pPr>
            <a:lvl6pPr marL="3563752" indent="0">
              <a:buNone/>
              <a:defRPr sz="1559"/>
            </a:lvl6pPr>
            <a:lvl7pPr marL="4276502" indent="0">
              <a:buNone/>
              <a:defRPr sz="1559"/>
            </a:lvl7pPr>
            <a:lvl8pPr marL="4989253" indent="0">
              <a:buNone/>
              <a:defRPr sz="1559"/>
            </a:lvl8pPr>
            <a:lvl9pPr marL="5702002" indent="0">
              <a:buNone/>
              <a:defRPr sz="1559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19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712788"/>
            <a:ext cx="4876384" cy="2494756"/>
          </a:xfrm>
        </p:spPr>
        <p:txBody>
          <a:bodyPr anchor="b"/>
          <a:lstStyle>
            <a:lvl1pPr>
              <a:defRPr sz="4989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27699" y="1539428"/>
            <a:ext cx="7654171" cy="7598117"/>
          </a:xfrm>
        </p:spPr>
        <p:txBody>
          <a:bodyPr anchor="t"/>
          <a:lstStyle>
            <a:lvl1pPr marL="0" indent="0">
              <a:buNone/>
              <a:defRPr sz="4989"/>
            </a:lvl1pPr>
            <a:lvl2pPr marL="712751" indent="0">
              <a:buNone/>
              <a:defRPr sz="4365"/>
            </a:lvl2pPr>
            <a:lvl3pPr marL="1425501" indent="0">
              <a:buNone/>
              <a:defRPr sz="3742"/>
            </a:lvl3pPr>
            <a:lvl4pPr marL="2138250" indent="0">
              <a:buNone/>
              <a:defRPr sz="3118"/>
            </a:lvl4pPr>
            <a:lvl5pPr marL="2851001" indent="0">
              <a:buNone/>
              <a:defRPr sz="3118"/>
            </a:lvl5pPr>
            <a:lvl6pPr marL="3563752" indent="0">
              <a:buNone/>
              <a:defRPr sz="3118"/>
            </a:lvl6pPr>
            <a:lvl7pPr marL="4276502" indent="0">
              <a:buNone/>
              <a:defRPr sz="3118"/>
            </a:lvl7pPr>
            <a:lvl8pPr marL="4989253" indent="0">
              <a:buNone/>
              <a:defRPr sz="3118"/>
            </a:lvl8pPr>
            <a:lvl9pPr marL="5702002" indent="0">
              <a:buNone/>
              <a:defRPr sz="3118"/>
            </a:lvl9pPr>
          </a:lstStyle>
          <a:p>
            <a:r>
              <a:rPr lang="da-DK" dirty="0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3207544"/>
            <a:ext cx="4876384" cy="5942372"/>
          </a:xfrm>
        </p:spPr>
        <p:txBody>
          <a:bodyPr/>
          <a:lstStyle>
            <a:lvl1pPr marL="0" indent="0">
              <a:buNone/>
              <a:defRPr sz="2494"/>
            </a:lvl1pPr>
            <a:lvl2pPr marL="712751" indent="0">
              <a:buNone/>
              <a:defRPr sz="2183"/>
            </a:lvl2pPr>
            <a:lvl3pPr marL="1425501" indent="0">
              <a:buNone/>
              <a:defRPr sz="1871"/>
            </a:lvl3pPr>
            <a:lvl4pPr marL="2138250" indent="0">
              <a:buNone/>
              <a:defRPr sz="1559"/>
            </a:lvl4pPr>
            <a:lvl5pPr marL="2851001" indent="0">
              <a:buNone/>
              <a:defRPr sz="1559"/>
            </a:lvl5pPr>
            <a:lvl6pPr marL="3563752" indent="0">
              <a:buNone/>
              <a:defRPr sz="1559"/>
            </a:lvl6pPr>
            <a:lvl7pPr marL="4276502" indent="0">
              <a:buNone/>
              <a:defRPr sz="1559"/>
            </a:lvl7pPr>
            <a:lvl8pPr marL="4989253" indent="0">
              <a:buNone/>
              <a:defRPr sz="1559"/>
            </a:lvl8pPr>
            <a:lvl9pPr marL="5702002" indent="0">
              <a:buNone/>
              <a:defRPr sz="1559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679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39462" y="569242"/>
            <a:ext cx="1304043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9462" y="2846203"/>
            <a:ext cx="13040439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39455" y="9909732"/>
            <a:ext cx="340185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97165-7307-46E1-B65D-34216DE7500E}" type="datetimeFigureOut">
              <a:rPr lang="en-US" smtClean="0"/>
              <a:t>2/27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08291" y="9909732"/>
            <a:ext cx="510278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678041" y="9909732"/>
            <a:ext cx="340185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7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0E5647-FC95-4806-9F80-56AD9BCA34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2934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425501" rtl="0" eaLnBrk="1" latinLnBrk="0" hangingPunct="1">
        <a:lnSpc>
          <a:spcPct val="90000"/>
        </a:lnSpc>
        <a:spcBef>
          <a:spcPct val="0"/>
        </a:spcBef>
        <a:buNone/>
        <a:defRPr sz="68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6375" indent="-356375" algn="l" defTabSz="1425501" rtl="0" eaLnBrk="1" latinLnBrk="0" hangingPunct="1">
        <a:lnSpc>
          <a:spcPct val="90000"/>
        </a:lnSpc>
        <a:spcBef>
          <a:spcPts val="1559"/>
        </a:spcBef>
        <a:buFont typeface="Arial" panose="020B0604020202020204" pitchFamily="34" charset="0"/>
        <a:buChar char="•"/>
        <a:defRPr sz="4365" kern="1200">
          <a:solidFill>
            <a:schemeClr val="tx1"/>
          </a:solidFill>
          <a:latin typeface="+mn-lt"/>
          <a:ea typeface="+mn-ea"/>
          <a:cs typeface="+mn-cs"/>
        </a:defRPr>
      </a:lvl1pPr>
      <a:lvl2pPr marL="1069126" indent="-356375" algn="l" defTabSz="1425501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3742" kern="1200">
          <a:solidFill>
            <a:schemeClr val="tx1"/>
          </a:solidFill>
          <a:latin typeface="+mn-lt"/>
          <a:ea typeface="+mn-ea"/>
          <a:cs typeface="+mn-cs"/>
        </a:defRPr>
      </a:lvl2pPr>
      <a:lvl3pPr marL="1781875" indent="-356375" algn="l" defTabSz="1425501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3pPr>
      <a:lvl4pPr marL="2494626" indent="-356375" algn="l" defTabSz="1425501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6" kern="1200">
          <a:solidFill>
            <a:schemeClr val="tx1"/>
          </a:solidFill>
          <a:latin typeface="+mn-lt"/>
          <a:ea typeface="+mn-ea"/>
          <a:cs typeface="+mn-cs"/>
        </a:defRPr>
      </a:lvl4pPr>
      <a:lvl5pPr marL="3207377" indent="-356375" algn="l" defTabSz="1425501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6" kern="1200">
          <a:solidFill>
            <a:schemeClr val="tx1"/>
          </a:solidFill>
          <a:latin typeface="+mn-lt"/>
          <a:ea typeface="+mn-ea"/>
          <a:cs typeface="+mn-cs"/>
        </a:defRPr>
      </a:lvl5pPr>
      <a:lvl6pPr marL="3920126" indent="-356375" algn="l" defTabSz="1425501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6" kern="1200">
          <a:solidFill>
            <a:schemeClr val="tx1"/>
          </a:solidFill>
          <a:latin typeface="+mn-lt"/>
          <a:ea typeface="+mn-ea"/>
          <a:cs typeface="+mn-cs"/>
        </a:defRPr>
      </a:lvl6pPr>
      <a:lvl7pPr marL="4632877" indent="-356375" algn="l" defTabSz="1425501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6" kern="1200">
          <a:solidFill>
            <a:schemeClr val="tx1"/>
          </a:solidFill>
          <a:latin typeface="+mn-lt"/>
          <a:ea typeface="+mn-ea"/>
          <a:cs typeface="+mn-cs"/>
        </a:defRPr>
      </a:lvl7pPr>
      <a:lvl8pPr marL="5345627" indent="-356375" algn="l" defTabSz="1425501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6" kern="1200">
          <a:solidFill>
            <a:schemeClr val="tx1"/>
          </a:solidFill>
          <a:latin typeface="+mn-lt"/>
          <a:ea typeface="+mn-ea"/>
          <a:cs typeface="+mn-cs"/>
        </a:defRPr>
      </a:lvl8pPr>
      <a:lvl9pPr marL="6058378" indent="-356375" algn="l" defTabSz="1425501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25501" rtl="0" eaLnBrk="1" latinLnBrk="0" hangingPunct="1">
        <a:defRPr sz="2806" kern="1200">
          <a:solidFill>
            <a:schemeClr val="tx1"/>
          </a:solidFill>
          <a:latin typeface="+mn-lt"/>
          <a:ea typeface="+mn-ea"/>
          <a:cs typeface="+mn-cs"/>
        </a:defRPr>
      </a:lvl1pPr>
      <a:lvl2pPr marL="712751" algn="l" defTabSz="1425501" rtl="0" eaLnBrk="1" latinLnBrk="0" hangingPunct="1">
        <a:defRPr sz="2806" kern="1200">
          <a:solidFill>
            <a:schemeClr val="tx1"/>
          </a:solidFill>
          <a:latin typeface="+mn-lt"/>
          <a:ea typeface="+mn-ea"/>
          <a:cs typeface="+mn-cs"/>
        </a:defRPr>
      </a:lvl2pPr>
      <a:lvl3pPr marL="1425501" algn="l" defTabSz="1425501" rtl="0" eaLnBrk="1" latinLnBrk="0" hangingPunct="1">
        <a:defRPr sz="2806" kern="1200">
          <a:solidFill>
            <a:schemeClr val="tx1"/>
          </a:solidFill>
          <a:latin typeface="+mn-lt"/>
          <a:ea typeface="+mn-ea"/>
          <a:cs typeface="+mn-cs"/>
        </a:defRPr>
      </a:lvl3pPr>
      <a:lvl4pPr marL="2138250" algn="l" defTabSz="1425501" rtl="0" eaLnBrk="1" latinLnBrk="0" hangingPunct="1">
        <a:defRPr sz="2806" kern="1200">
          <a:solidFill>
            <a:schemeClr val="tx1"/>
          </a:solidFill>
          <a:latin typeface="+mn-lt"/>
          <a:ea typeface="+mn-ea"/>
          <a:cs typeface="+mn-cs"/>
        </a:defRPr>
      </a:lvl4pPr>
      <a:lvl5pPr marL="2851001" algn="l" defTabSz="1425501" rtl="0" eaLnBrk="1" latinLnBrk="0" hangingPunct="1">
        <a:defRPr sz="2806" kern="1200">
          <a:solidFill>
            <a:schemeClr val="tx1"/>
          </a:solidFill>
          <a:latin typeface="+mn-lt"/>
          <a:ea typeface="+mn-ea"/>
          <a:cs typeface="+mn-cs"/>
        </a:defRPr>
      </a:lvl5pPr>
      <a:lvl6pPr marL="3563752" algn="l" defTabSz="1425501" rtl="0" eaLnBrk="1" latinLnBrk="0" hangingPunct="1">
        <a:defRPr sz="2806" kern="1200">
          <a:solidFill>
            <a:schemeClr val="tx1"/>
          </a:solidFill>
          <a:latin typeface="+mn-lt"/>
          <a:ea typeface="+mn-ea"/>
          <a:cs typeface="+mn-cs"/>
        </a:defRPr>
      </a:lvl6pPr>
      <a:lvl7pPr marL="4276502" algn="l" defTabSz="1425501" rtl="0" eaLnBrk="1" latinLnBrk="0" hangingPunct="1">
        <a:defRPr sz="2806" kern="1200">
          <a:solidFill>
            <a:schemeClr val="tx1"/>
          </a:solidFill>
          <a:latin typeface="+mn-lt"/>
          <a:ea typeface="+mn-ea"/>
          <a:cs typeface="+mn-cs"/>
        </a:defRPr>
      </a:lvl7pPr>
      <a:lvl8pPr marL="4989253" algn="l" defTabSz="1425501" rtl="0" eaLnBrk="1" latinLnBrk="0" hangingPunct="1">
        <a:defRPr sz="2806" kern="1200">
          <a:solidFill>
            <a:schemeClr val="tx1"/>
          </a:solidFill>
          <a:latin typeface="+mn-lt"/>
          <a:ea typeface="+mn-ea"/>
          <a:cs typeface="+mn-cs"/>
        </a:defRPr>
      </a:lvl8pPr>
      <a:lvl9pPr marL="5702002" algn="l" defTabSz="1425501" rtl="0" eaLnBrk="1" latinLnBrk="0" hangingPunct="1">
        <a:defRPr sz="280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7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1205" y="145915"/>
            <a:ext cx="24461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Supplementary material</a:t>
            </a:r>
          </a:p>
          <a:p>
            <a:r>
              <a:rPr lang="da-DK" dirty="0"/>
              <a:t>Figure </a:t>
            </a:r>
            <a:r>
              <a:rPr lang="da-DK" dirty="0" smtClean="0"/>
              <a:t>S1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3880100" y="2804893"/>
            <a:ext cx="7078525" cy="3822834"/>
            <a:chOff x="2660898" y="829339"/>
            <a:chExt cx="7078525" cy="3822834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0898" y="2285991"/>
              <a:ext cx="1548597" cy="1420111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3110" y="1307803"/>
              <a:ext cx="1536183" cy="141801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93606" y="1307803"/>
              <a:ext cx="1545817" cy="1426908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3110" y="3232285"/>
              <a:ext cx="1536183" cy="1418015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32908" y="3232284"/>
              <a:ext cx="1558425" cy="1418015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84948" y="3232285"/>
              <a:ext cx="1554475" cy="1419888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2977117" y="1807527"/>
              <a:ext cx="889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Control</a:t>
              </a:r>
              <a:endParaRPr lang="en-US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729450" y="829339"/>
              <a:ext cx="10835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0.5 M KCl</a:t>
              </a:r>
              <a:endParaRPr lang="en-US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509400" y="829339"/>
              <a:ext cx="9055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2 M KCl</a:t>
              </a:r>
              <a:endParaRPr lang="en-US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659335" y="839971"/>
              <a:ext cx="9055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1 M KCl</a:t>
              </a:r>
              <a:endParaRPr lang="en-US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686918" y="2789285"/>
              <a:ext cx="12314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0.5 M NaCl</a:t>
              </a:r>
              <a:endParaRPr lang="en-US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8466868" y="2789285"/>
              <a:ext cx="1053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2 M NaCl</a:t>
              </a:r>
              <a:endParaRPr lang="en-US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616803" y="2799917"/>
              <a:ext cx="1053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1 M NaCl</a:t>
              </a:r>
              <a:endParaRPr lang="en-US" b="1" dirty="0"/>
            </a:p>
          </p:txBody>
        </p: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32908" y="1307803"/>
              <a:ext cx="1558425" cy="1410284"/>
            </a:xfrm>
            <a:prstGeom prst="rect">
              <a:avLst/>
            </a:prstGeom>
          </p:spPr>
        </p:pic>
      </p:grpSp>
      <p:sp>
        <p:nvSpPr>
          <p:cNvPr id="19" name="TextBox 18"/>
          <p:cNvSpPr txBox="1"/>
          <p:nvPr/>
        </p:nvSpPr>
        <p:spPr>
          <a:xfrm>
            <a:off x="3781778" y="7123427"/>
            <a:ext cx="727004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a-DK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da-DK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da-DK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a-DK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baryomyces hansenii</a:t>
            </a:r>
            <a:r>
              <a:rPr lang="da-DK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the microscope (100x magnification). Yeast cells were grown in flasks in YNB medium (pH 6, 2% of glucose) with or without KCl/NaCl, and pictures were taken after 51 h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79275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1205" y="145915"/>
            <a:ext cx="24461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Supplementary material</a:t>
            </a:r>
          </a:p>
          <a:p>
            <a:r>
              <a:rPr lang="da-DK" dirty="0"/>
              <a:t>Figure </a:t>
            </a:r>
            <a:r>
              <a:rPr lang="da-DK" dirty="0" smtClean="0"/>
              <a:t>S2</a:t>
            </a:r>
            <a:endParaRPr lang="en-US" dirty="0"/>
          </a:p>
        </p:txBody>
      </p:sp>
      <p:sp>
        <p:nvSpPr>
          <p:cNvPr id="5" name="Rectangle 4"/>
          <p:cNvSpPr/>
          <p:nvPr/>
        </p:nvSpPr>
        <p:spPr>
          <a:xfrm>
            <a:off x="798724" y="9159692"/>
            <a:ext cx="13749867" cy="981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y weight (g/L) and glucose consumption (g/L) profiles over time (h) for batch cultivations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baryomyces hanseni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nder normal glucose conditions. The cells were grown in synthetic complete media containing 2% of glucose at 28°C with an initial pH value of 6, and with or without salts as stated in the figure. Data shown are from representative experiments of their associated replicates.</a:t>
            </a:r>
            <a:endParaRPr lang="da-DK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7" name="Group 36"/>
          <p:cNvGrpSpPr/>
          <p:nvPr/>
        </p:nvGrpSpPr>
        <p:grpSpPr>
          <a:xfrm>
            <a:off x="120937" y="1634406"/>
            <a:ext cx="15618557" cy="7056211"/>
            <a:chOff x="201619" y="881374"/>
            <a:chExt cx="15618557" cy="7056211"/>
          </a:xfrm>
        </p:grpSpPr>
        <p:grpSp>
          <p:nvGrpSpPr>
            <p:cNvPr id="6" name="Group 5"/>
            <p:cNvGrpSpPr/>
            <p:nvPr/>
          </p:nvGrpSpPr>
          <p:grpSpPr>
            <a:xfrm>
              <a:off x="223846" y="881374"/>
              <a:ext cx="3054685" cy="2204270"/>
              <a:chOff x="316155" y="3846762"/>
              <a:chExt cx="3682156" cy="2555965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16155" y="3846762"/>
                <a:ext cx="3682156" cy="2555965"/>
              </a:xfrm>
              <a:prstGeom prst="rect">
                <a:avLst/>
              </a:prstGeom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316155" y="6070311"/>
                <a:ext cx="798260" cy="28497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20" dirty="0"/>
                  <a:t>Control</a:t>
                </a: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3249099" y="3264221"/>
              <a:ext cx="3060512" cy="2204270"/>
              <a:chOff x="7522323" y="2701093"/>
              <a:chExt cx="3060512" cy="2204270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7522323" y="2701093"/>
                <a:ext cx="3060512" cy="2204270"/>
              </a:xfrm>
              <a:prstGeom prst="rect">
                <a:avLst/>
              </a:prstGeom>
            </p:spPr>
          </p:pic>
          <p:sp>
            <p:nvSpPr>
              <p:cNvPr id="11" name="TextBox 10"/>
              <p:cNvSpPr txBox="1"/>
              <p:nvPr/>
            </p:nvSpPr>
            <p:spPr>
              <a:xfrm>
                <a:off x="7552633" y="4591001"/>
                <a:ext cx="726892" cy="2640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/>
                  <a:t>1M NaCl</a:t>
                </a: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6310489" y="3264221"/>
              <a:ext cx="3201997" cy="2204270"/>
              <a:chOff x="7522323" y="451560"/>
              <a:chExt cx="3060512" cy="2129555"/>
            </a:xfrm>
          </p:grpSpPr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522323" y="451560"/>
                <a:ext cx="3060512" cy="2129555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7522323" y="2250769"/>
                <a:ext cx="1036018" cy="2640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/>
                  <a:t>1.25M NaCl</a:t>
                </a: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9512486" y="3267648"/>
              <a:ext cx="3163875" cy="2200843"/>
              <a:chOff x="7522323" y="5013869"/>
              <a:chExt cx="3060512" cy="2150528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7522323" y="5013869"/>
                <a:ext cx="3060512" cy="2150528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7522323" y="6841074"/>
                <a:ext cx="1118905" cy="2640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/>
                  <a:t>1.5M NaCl</a:t>
                </a:r>
              </a:p>
            </p:txBody>
          </p:sp>
        </p:grpSp>
        <p:grpSp>
          <p:nvGrpSpPr>
            <p:cNvPr id="18" name="Group 17"/>
            <p:cNvGrpSpPr/>
            <p:nvPr/>
          </p:nvGrpSpPr>
          <p:grpSpPr>
            <a:xfrm>
              <a:off x="6335678" y="5646785"/>
              <a:ext cx="3176808" cy="2282564"/>
              <a:chOff x="4247914" y="2701093"/>
              <a:chExt cx="3063281" cy="2204269"/>
            </a:xfrm>
          </p:grpSpPr>
          <p:pic>
            <p:nvPicPr>
              <p:cNvPr id="19" name="Picture 18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247914" y="2701093"/>
                <a:ext cx="3063281" cy="2204269"/>
              </a:xfrm>
              <a:prstGeom prst="rect">
                <a:avLst/>
              </a:prstGeom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4298962" y="4589136"/>
                <a:ext cx="1036018" cy="2640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/>
                  <a:t>1.25M KCl</a:t>
                </a: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9512486" y="5655315"/>
              <a:ext cx="3163875" cy="2274034"/>
              <a:chOff x="4247914" y="5013870"/>
              <a:chExt cx="3063281" cy="2162000"/>
            </a:xfrm>
          </p:grpSpPr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247914" y="5013870"/>
                <a:ext cx="3063281" cy="2162000"/>
              </a:xfrm>
              <a:prstGeom prst="rect">
                <a:avLst/>
              </a:prstGeom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4297072" y="6837385"/>
                <a:ext cx="1118905" cy="2640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/>
                  <a:t>1.5M KCl</a:t>
                </a: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3249099" y="5646785"/>
              <a:ext cx="3086579" cy="2282564"/>
              <a:chOff x="4247914" y="427224"/>
              <a:chExt cx="3063281" cy="2126374"/>
            </a:xfrm>
          </p:grpSpPr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247914" y="427224"/>
                <a:ext cx="3063281" cy="2126374"/>
              </a:xfrm>
              <a:prstGeom prst="rect">
                <a:avLst/>
              </a:prstGeom>
            </p:spPr>
          </p:pic>
          <p:sp>
            <p:nvSpPr>
              <p:cNvPr id="26" name="TextBox 25"/>
              <p:cNvSpPr txBox="1"/>
              <p:nvPr/>
            </p:nvSpPr>
            <p:spPr>
              <a:xfrm>
                <a:off x="4338516" y="2223252"/>
                <a:ext cx="726892" cy="2640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/>
                  <a:t>1M KCl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12676361" y="3264221"/>
              <a:ext cx="3143814" cy="2204270"/>
              <a:chOff x="12676361" y="3264221"/>
              <a:chExt cx="3143814" cy="2204270"/>
            </a:xfrm>
          </p:grpSpPr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2676361" y="3264221"/>
                <a:ext cx="3143814" cy="2204270"/>
              </a:xfrm>
              <a:prstGeom prst="rect">
                <a:avLst/>
              </a:prstGeom>
            </p:spPr>
          </p:pic>
          <p:sp>
            <p:nvSpPr>
              <p:cNvPr id="28" name="TextBox 27"/>
              <p:cNvSpPr txBox="1"/>
              <p:nvPr/>
            </p:nvSpPr>
            <p:spPr>
              <a:xfrm>
                <a:off x="12714483" y="5126555"/>
                <a:ext cx="1156694" cy="2702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 smtClean="0"/>
                  <a:t>2M </a:t>
                </a:r>
                <a:r>
                  <a:rPr lang="da-DK" sz="1116" dirty="0"/>
                  <a:t>NaCl</a:t>
                </a:r>
              </a:p>
            </p:txBody>
          </p:sp>
        </p:grpSp>
        <p:grpSp>
          <p:nvGrpSpPr>
            <p:cNvPr id="32" name="Group 31"/>
            <p:cNvGrpSpPr/>
            <p:nvPr/>
          </p:nvGrpSpPr>
          <p:grpSpPr>
            <a:xfrm>
              <a:off x="12676362" y="5646785"/>
              <a:ext cx="3143814" cy="2280857"/>
              <a:chOff x="12676362" y="5646785"/>
              <a:chExt cx="3143814" cy="2280857"/>
            </a:xfrm>
          </p:grpSpPr>
          <p:pic>
            <p:nvPicPr>
              <p:cNvPr id="30" name="Picture 29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2676362" y="5646785"/>
                <a:ext cx="3143814" cy="2280857"/>
              </a:xfrm>
              <a:prstGeom prst="rect">
                <a:avLst/>
              </a:prstGeom>
            </p:spPr>
          </p:pic>
          <p:sp>
            <p:nvSpPr>
              <p:cNvPr id="31" name="TextBox 30"/>
              <p:cNvSpPr txBox="1"/>
              <p:nvPr/>
            </p:nvSpPr>
            <p:spPr>
              <a:xfrm>
                <a:off x="12727133" y="7601891"/>
                <a:ext cx="1156694" cy="2702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 smtClean="0"/>
                  <a:t>2M </a:t>
                </a:r>
                <a:r>
                  <a:rPr lang="da-DK" sz="1116" dirty="0"/>
                  <a:t>K</a:t>
                </a:r>
                <a:r>
                  <a:rPr lang="da-DK" sz="1116" dirty="0" smtClean="0"/>
                  <a:t>Cl</a:t>
                </a:r>
                <a:endParaRPr lang="da-DK" sz="1116" dirty="0"/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217140" y="3264221"/>
              <a:ext cx="3061391" cy="2204270"/>
              <a:chOff x="217140" y="3264221"/>
              <a:chExt cx="3061391" cy="2204270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18019" y="3264221"/>
                <a:ext cx="3060512" cy="2204270"/>
              </a:xfrm>
              <a:prstGeom prst="rect">
                <a:avLst/>
              </a:prstGeom>
            </p:spPr>
          </p:pic>
          <p:sp>
            <p:nvSpPr>
              <p:cNvPr id="33" name="TextBox 32"/>
              <p:cNvSpPr txBox="1"/>
              <p:nvPr/>
            </p:nvSpPr>
            <p:spPr>
              <a:xfrm>
                <a:off x="217140" y="5132733"/>
                <a:ext cx="944183" cy="2640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 smtClean="0"/>
                  <a:t>0.5M </a:t>
                </a:r>
                <a:r>
                  <a:rPr lang="da-DK" sz="1116" dirty="0"/>
                  <a:t>NaCl</a:t>
                </a:r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201619" y="5646785"/>
              <a:ext cx="3060513" cy="2290800"/>
              <a:chOff x="201619" y="5646785"/>
              <a:chExt cx="3060513" cy="2290800"/>
            </a:xfrm>
          </p:grpSpPr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01619" y="5646785"/>
                <a:ext cx="3060513" cy="2290800"/>
              </a:xfrm>
              <a:prstGeom prst="rect">
                <a:avLst/>
              </a:prstGeom>
            </p:spPr>
          </p:pic>
          <p:sp>
            <p:nvSpPr>
              <p:cNvPr id="34" name="TextBox 33"/>
              <p:cNvSpPr txBox="1"/>
              <p:nvPr/>
            </p:nvSpPr>
            <p:spPr>
              <a:xfrm>
                <a:off x="223846" y="7567338"/>
                <a:ext cx="732420" cy="2640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a-DK" sz="1116" dirty="0" smtClean="0"/>
                  <a:t>0.5M </a:t>
                </a:r>
                <a:r>
                  <a:rPr lang="da-DK" sz="1116" dirty="0"/>
                  <a:t>KCl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943103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1205" y="145915"/>
            <a:ext cx="24461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Supplementary material</a:t>
            </a:r>
          </a:p>
          <a:p>
            <a:r>
              <a:rPr lang="da-DK" dirty="0"/>
              <a:t>Figure </a:t>
            </a:r>
            <a:r>
              <a:rPr lang="da-DK" dirty="0" smtClean="0"/>
              <a:t>S3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7350" y="3730328"/>
            <a:ext cx="8504657" cy="323116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3118924" y="7390127"/>
            <a:ext cx="9287567" cy="15741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.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ptical density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00nm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baryomyces hanseni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over time. Cells were inoculated in synthetic media at pH 6 containing 0.2% of glucose, and with or without NaCl/KCl. Cell growth in flasks was monitored during 191 hours at 28°C, 150 rpm. Data shown are mean values of duplicated experiments.</a:t>
            </a: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nal data points were taken to confirm, by HPLC analysis, that glucose had been completely consumed.</a:t>
            </a:r>
            <a:endParaRPr lang="da-DK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91810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553571" y="989084"/>
            <a:ext cx="14173988" cy="7775562"/>
            <a:chOff x="553571" y="684281"/>
            <a:chExt cx="14173988" cy="7775562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53571" y="1208951"/>
              <a:ext cx="4572396" cy="3261643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553571" y="689927"/>
              <a:ext cx="11543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A) Control</a:t>
              </a:r>
              <a:endParaRPr lang="en-US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373916" y="689927"/>
              <a:ext cx="13083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B) 1M NaCl </a:t>
              </a:r>
              <a:endParaRPr lang="en-US" b="1" dirty="0"/>
            </a:p>
          </p:txBody>
        </p:sp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73916" y="1208951"/>
              <a:ext cx="4572396" cy="3237257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571203" y="4646683"/>
              <a:ext cx="12715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D) 2M NaCl</a:t>
              </a:r>
              <a:endParaRPr lang="en-US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373916" y="4646683"/>
              <a:ext cx="108991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E) 2M KCl</a:t>
              </a:r>
              <a:endParaRPr lang="en-US" b="1" dirty="0"/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155163" y="1208950"/>
              <a:ext cx="4572396" cy="3237257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0177344" y="684281"/>
              <a:ext cx="10995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b="1" dirty="0"/>
                <a:t>C) 1M KCl</a:t>
              </a:r>
              <a:endParaRPr lang="en-US" b="1" dirty="0"/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1203" y="5192104"/>
              <a:ext cx="4572396" cy="3255546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373916" y="5192104"/>
              <a:ext cx="4572396" cy="3267739"/>
            </a:xfrm>
            <a:prstGeom prst="rect">
              <a:avLst/>
            </a:prstGeom>
          </p:spPr>
        </p:pic>
      </p:grpSp>
      <p:sp>
        <p:nvSpPr>
          <p:cNvPr id="15" name="TextBox 14"/>
          <p:cNvSpPr txBox="1"/>
          <p:nvPr/>
        </p:nvSpPr>
        <p:spPr>
          <a:xfrm>
            <a:off x="571205" y="145915"/>
            <a:ext cx="24461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Supplementary material</a:t>
            </a:r>
          </a:p>
          <a:p>
            <a:r>
              <a:rPr lang="da-DK" dirty="0"/>
              <a:t>Figure </a:t>
            </a:r>
            <a:r>
              <a:rPr lang="da-DK" dirty="0" smtClean="0"/>
              <a:t>S4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553573" y="9019832"/>
            <a:ext cx="13952651" cy="981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.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ry weight (g/L), glucose consumption (g/L) and optical density (A</a:t>
            </a:r>
            <a:r>
              <a:rPr lang="en-US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600nm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profiles over time (h) for batch cultivations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baryomyces hanseni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nder limiting glucose conditions and without pH regulation. The cells were grown in synthetic complete media containing 0.2% of glucose at 28°C with an initial pH value of 6, and with or without salts as stated in the figure. Data shown are mean values of duplicated experiments.</a:t>
            </a:r>
            <a:endParaRPr lang="da-DK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68811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1127072" y="1445726"/>
            <a:ext cx="12586209" cy="7697732"/>
            <a:chOff x="1127069" y="1445724"/>
            <a:chExt cx="12586209" cy="7697732"/>
          </a:xfrm>
        </p:grpSpPr>
        <p:grpSp>
          <p:nvGrpSpPr>
            <p:cNvPr id="2" name="Group 1"/>
            <p:cNvGrpSpPr/>
            <p:nvPr/>
          </p:nvGrpSpPr>
          <p:grpSpPr>
            <a:xfrm>
              <a:off x="4589252" y="1445724"/>
              <a:ext cx="5656923" cy="3684532"/>
              <a:chOff x="4589252" y="1445724"/>
              <a:chExt cx="5656923" cy="3684532"/>
            </a:xfrm>
          </p:grpSpPr>
          <p:pic>
            <p:nvPicPr>
              <p:cNvPr id="5" name="Billede 4">
                <a:extLst>
                  <a:ext uri="{FF2B5EF4-FFF2-40B4-BE49-F238E27FC236}">
                    <a16:creationId xmlns:a16="http://schemas.microsoft.com/office/drawing/2014/main" id="{9846FCB7-D841-4822-8DB7-380E92D28B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873174" y="1815056"/>
                <a:ext cx="5373001" cy="3315200"/>
              </a:xfrm>
              <a:prstGeom prst="rect">
                <a:avLst/>
              </a:prstGeom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4589252" y="1445724"/>
                <a:ext cx="3962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b="1" dirty="0"/>
                  <a:t>A)</a:t>
                </a:r>
                <a:endParaRPr lang="en-US" b="1" dirty="0"/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1127069" y="5458924"/>
              <a:ext cx="5652006" cy="3684532"/>
              <a:chOff x="1127069" y="5458924"/>
              <a:chExt cx="5652006" cy="3684532"/>
            </a:xfrm>
          </p:grpSpPr>
          <p:pic>
            <p:nvPicPr>
              <p:cNvPr id="6" name="Billede 5">
                <a:extLst>
                  <a:ext uri="{FF2B5EF4-FFF2-40B4-BE49-F238E27FC236}">
                    <a16:creationId xmlns:a16="http://schemas.microsoft.com/office/drawing/2014/main" id="{319CF13D-7C2E-47CA-9F87-551AAAF072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406074" y="5828256"/>
                <a:ext cx="5373001" cy="3315200"/>
              </a:xfrm>
              <a:prstGeom prst="rect">
                <a:avLst/>
              </a:prstGeom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1127069" y="5458924"/>
                <a:ext cx="38664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b="1" dirty="0"/>
                  <a:t>B)</a:t>
                </a:r>
                <a:endParaRPr lang="en-US" b="1" dirty="0"/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8041459" y="5458924"/>
              <a:ext cx="5671819" cy="3684532"/>
              <a:chOff x="8041459" y="5458924"/>
              <a:chExt cx="5671819" cy="3684532"/>
            </a:xfrm>
          </p:grpSpPr>
          <p:pic>
            <p:nvPicPr>
              <p:cNvPr id="7" name="Billede 6">
                <a:extLst>
                  <a:ext uri="{FF2B5EF4-FFF2-40B4-BE49-F238E27FC236}">
                    <a16:creationId xmlns:a16="http://schemas.microsoft.com/office/drawing/2014/main" id="{341B81A3-B205-446D-BFE5-C3B6A5C9B0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340277" y="5828256"/>
                <a:ext cx="5373001" cy="3315200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8041459" y="5458924"/>
                <a:ext cx="37863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b="1" dirty="0"/>
                  <a:t>C)</a:t>
                </a:r>
                <a:endParaRPr lang="en-US" b="1" dirty="0"/>
              </a:p>
            </p:txBody>
          </p:sp>
        </p:grpSp>
      </p:grpSp>
      <p:sp>
        <p:nvSpPr>
          <p:cNvPr id="11" name="TextBox 10"/>
          <p:cNvSpPr txBox="1"/>
          <p:nvPr/>
        </p:nvSpPr>
        <p:spPr>
          <a:xfrm>
            <a:off x="445170" y="204539"/>
            <a:ext cx="24461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Supplementary material</a:t>
            </a:r>
          </a:p>
          <a:p>
            <a:r>
              <a:rPr lang="da-DK" dirty="0"/>
              <a:t>Figure </a:t>
            </a:r>
            <a:r>
              <a:rPr lang="da-DK" dirty="0" smtClean="0"/>
              <a:t>S5</a:t>
            </a:r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1127071" y="9350747"/>
            <a:ext cx="13408102" cy="981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5.</a:t>
            </a:r>
            <a:r>
              <a:rPr lang="en-US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 profiles for batch cultivations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baryomyces hanseni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without pH regulation. The figures show the measured pH over time (h) for batch cultivations without pH regulation in synthetic complete media at 28°C with an initial pH value of 6. The cells were either grown without salts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NaCl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r KCl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As indicated by the color pattern, the pH profiles are a result of several independent replicates.</a:t>
            </a:r>
            <a:endParaRPr lang="da-DK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06712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1205" y="145915"/>
            <a:ext cx="24461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Supplementary material</a:t>
            </a:r>
          </a:p>
          <a:p>
            <a:r>
              <a:rPr lang="da-DK" dirty="0"/>
              <a:t>Figure </a:t>
            </a:r>
            <a:r>
              <a:rPr lang="da-DK" dirty="0" smtClean="0"/>
              <a:t>S6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01048" y="3080552"/>
            <a:ext cx="6050924" cy="4683030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2628375" y="8225501"/>
            <a:ext cx="9913585" cy="12777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6.</a:t>
            </a:r>
            <a:r>
              <a:rPr lang="en-US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 profiles for batch cultivations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baryomyces hansenii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nder limiting glucose conditions and without pH regulation. The figures show the measured pH over time (h) for batch cultivations in synthetic complete media with 0.2% of glucose, at 28°C and with an initial pH value of around 6. The cells were either grown without salts, NaCl or KCl. The pH profiles are a result of independent duplicates.</a:t>
            </a:r>
            <a:endParaRPr lang="da-DK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48136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1205" y="145915"/>
            <a:ext cx="244611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/>
              <a:t>Supplementary material</a:t>
            </a:r>
          </a:p>
          <a:p>
            <a:r>
              <a:rPr lang="da-DK" dirty="0"/>
              <a:t>Table S1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3120" y="2707267"/>
            <a:ext cx="6029149" cy="48447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1777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9</TotalTime>
  <Words>535</Words>
  <Application>Microsoft Office PowerPoint</Application>
  <PresentationFormat>Custom</PresentationFormat>
  <Paragraphs>46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-tema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JLMR</dc:creator>
  <cp:lastModifiedBy>Clara Navarrete Román</cp:lastModifiedBy>
  <cp:revision>59</cp:revision>
  <dcterms:created xsi:type="dcterms:W3CDTF">2019-04-12T09:18:12Z</dcterms:created>
  <dcterms:modified xsi:type="dcterms:W3CDTF">2020-02-27T08:33:14Z</dcterms:modified>
</cp:coreProperties>
</file>